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94"/>
  </p:normalViewPr>
  <p:slideViewPr>
    <p:cSldViewPr snapToGrid="0" showGuides="1">
      <p:cViewPr>
        <p:scale>
          <a:sx n="162" d="100"/>
          <a:sy n="162" d="100"/>
        </p:scale>
        <p:origin x="1976" y="-46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60603-7B14-AB44-9DE1-E2EF40323409}" type="datetimeFigureOut">
              <a:t>2024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4390D-E830-D04E-8250-9146598888E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504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25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56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91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19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1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1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51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94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67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7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3A49A2-03C3-66F9-FC60-7F776CE991D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68A679E5-2860-835C-11DE-09C0A429B3F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43903" y="7105910"/>
            <a:ext cx="570983" cy="109986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70DA0B2-7D7E-73F2-F26E-E92B172024BD}"/>
              </a:ext>
            </a:extLst>
          </p:cNvPr>
          <p:cNvSpPr txBox="1"/>
          <p:nvPr/>
        </p:nvSpPr>
        <p:spPr>
          <a:xfrm>
            <a:off x="1386029" y="8464100"/>
            <a:ext cx="458910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D-Genies-generated dot-plots showing similarities of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with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chacoense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a) and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verrucos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b).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7B71823-6714-E560-E287-88744C646392}"/>
              </a:ext>
            </a:extLst>
          </p:cNvPr>
          <p:cNvSpPr txBox="1"/>
          <p:nvPr/>
        </p:nvSpPr>
        <p:spPr>
          <a:xfrm>
            <a:off x="2692671" y="771973"/>
            <a:ext cx="1430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chacoense </a:t>
            </a:r>
            <a:r>
              <a:rPr kumimoji="1" lang="en-US" altLang="ja-JP" sz="800">
                <a:latin typeface="Helvetica" pitchFamily="2" charset="0"/>
              </a:rPr>
              <a:t>M6 v5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FE55C906-F569-9268-4EFE-CEFF89A2F1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3" y="4688124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" name="テキスト ボックス 26">
            <a:extLst>
              <a:ext uri="{FF2B5EF4-FFF2-40B4-BE49-F238E27FC236}">
                <a16:creationId xmlns:a16="http://schemas.microsoft.com/office/drawing/2014/main" id="{AA478AE4-2431-3AC6-B4CB-3C9B3FA427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4" y="879695"/>
            <a:ext cx="339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0E2708A-A2DD-312B-8B1F-ED1E11B1ED6D}"/>
              </a:ext>
            </a:extLst>
          </p:cNvPr>
          <p:cNvSpPr txBox="1"/>
          <p:nvPr/>
        </p:nvSpPr>
        <p:spPr>
          <a:xfrm rot="5400000">
            <a:off x="4418515" y="2553639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16E027C-A972-5F27-BC6C-8CD00CC170AC}"/>
              </a:ext>
            </a:extLst>
          </p:cNvPr>
          <p:cNvSpPr txBox="1"/>
          <p:nvPr/>
        </p:nvSpPr>
        <p:spPr>
          <a:xfrm>
            <a:off x="2486685" y="4580402"/>
            <a:ext cx="1491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verrucosum </a:t>
            </a:r>
            <a:r>
              <a:rPr kumimoji="1" lang="en-US" altLang="ja-JP" sz="800">
                <a:latin typeface="Helvetica" pitchFamily="2" charset="0"/>
              </a:rPr>
              <a:t>11H23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998B8E9-81BE-1827-AB32-57B8496BC745}"/>
              </a:ext>
            </a:extLst>
          </p:cNvPr>
          <p:cNvSpPr txBox="1"/>
          <p:nvPr/>
        </p:nvSpPr>
        <p:spPr>
          <a:xfrm rot="5400000">
            <a:off x="4418515" y="6371493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BF5FA10-62B6-1342-129B-A7AFB85C278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74290" y="968013"/>
            <a:ext cx="3553846" cy="354683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640249C9-0888-FD65-B34A-2B562EB2D95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74290" y="4770566"/>
            <a:ext cx="3563813" cy="3560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284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43</Words>
  <Application>Microsoft Macintosh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*</cp:lastModifiedBy>
  <cp:revision>12</cp:revision>
  <dcterms:created xsi:type="dcterms:W3CDTF">2023-11-03T07:37:49Z</dcterms:created>
  <dcterms:modified xsi:type="dcterms:W3CDTF">2024-04-19T22:53:39Z</dcterms:modified>
</cp:coreProperties>
</file>